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35" r:id="rId2"/>
    <p:sldId id="336" r:id="rId3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59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中野和久" initials="KN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72" autoAdjust="0"/>
    <p:restoredTop sz="94660" autoAdjust="0"/>
  </p:normalViewPr>
  <p:slideViewPr>
    <p:cSldViewPr snapToGrid="0" showGuides="1">
      <p:cViewPr varScale="1">
        <p:scale>
          <a:sx n="88" d="100"/>
          <a:sy n="88" d="100"/>
        </p:scale>
        <p:origin x="3424" y="176"/>
      </p:cViewPr>
      <p:guideLst>
        <p:guide orient="horz" pos="6159"/>
        <p:guide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yuppy0316\Desktop\20170403%20AAV%20J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val>
            <c:numRef>
              <c:f>Sheet2!$B$2</c:f>
              <c:numCache>
                <c:formatCode>General</c:formatCode>
                <c:ptCount val="1"/>
                <c:pt idx="0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9E-8045-8CB4-2027F89ECB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7049744"/>
        <c:axId val="200636768"/>
      </c:barChart>
      <c:catAx>
        <c:axId val="337049744"/>
        <c:scaling>
          <c:orientation val="minMax"/>
        </c:scaling>
        <c:delete val="1"/>
        <c:axPos val="b"/>
        <c:majorTickMark val="none"/>
        <c:minorTickMark val="none"/>
        <c:tickLblPos val="nextTo"/>
        <c:crossAx val="200636768"/>
        <c:crosses val="autoZero"/>
        <c:auto val="1"/>
        <c:lblAlgn val="ctr"/>
        <c:lblOffset val="100"/>
        <c:noMultiLvlLbl val="0"/>
      </c:catAx>
      <c:valAx>
        <c:axId val="200636768"/>
        <c:scaling>
          <c:orientation val="minMax"/>
          <c:max val="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ja-JP"/>
          </a:p>
        </c:txPr>
        <c:crossAx val="33704974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0" i="0">
          <a:latin typeface="Arial" charset="0"/>
          <a:ea typeface="Arial" charset="0"/>
          <a:cs typeface="Arial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9D37CC-3129-C54E-A820-5D5FD270E504}" type="datetimeFigureOut">
              <a:rPr kumimoji="1" lang="ja-JP" altLang="en-US" smtClean="0"/>
              <a:t>2021/4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89747B-6D93-E748-BB75-CE0EFD1E56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2073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7B280-CCE2-4099-A804-33D38535A511}" type="datetimeFigureOut">
              <a:rPr kumimoji="1" lang="ja-JP" altLang="en-US" smtClean="0"/>
              <a:pPr/>
              <a:t>2021/4/29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E520-E2F3-4FC4-9ED8-3C54FFA7FCA4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7CDAE629-6020-A04B-AF90-F716A6CC1E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5262" t="2347" r="3918" b="22427"/>
          <a:stretch/>
        </p:blipFill>
        <p:spPr>
          <a:xfrm>
            <a:off x="2219096" y="1741606"/>
            <a:ext cx="2620539" cy="1670135"/>
          </a:xfrm>
          <a:prstGeom prst="rect">
            <a:avLst/>
          </a:prstGeom>
        </p:spPr>
      </p:pic>
      <p:sp>
        <p:nvSpPr>
          <p:cNvPr id="2" name="正方形/長方形 1"/>
          <p:cNvSpPr/>
          <p:nvPr/>
        </p:nvSpPr>
        <p:spPr>
          <a:xfrm>
            <a:off x="100365" y="60216"/>
            <a:ext cx="177116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kern="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upplementary figure S1. </a:t>
            </a:r>
            <a:endParaRPr lang="ja-JP" altLang="ja-JP" sz="1000" kern="1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3692376"/>
              </p:ext>
            </p:extLst>
          </p:nvPr>
        </p:nvGraphicFramePr>
        <p:xfrm>
          <a:off x="1689186" y="1626630"/>
          <a:ext cx="1188000" cy="1992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6" name="直線コネクタ 5"/>
          <p:cNvCxnSpPr/>
          <p:nvPr/>
        </p:nvCxnSpPr>
        <p:spPr>
          <a:xfrm>
            <a:off x="2214970" y="3474254"/>
            <a:ext cx="273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 bwMode="auto">
          <a:xfrm>
            <a:off x="1957715" y="3718240"/>
            <a:ext cx="3240000" cy="253916"/>
          </a:xfrm>
          <a:prstGeom prst="rect">
            <a:avLst/>
          </a:prstGeom>
          <a:noFill/>
          <a:ln w="28575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0" lang="en-US" altLang="ja-JP" sz="1050" dirty="0">
                <a:uFill>
                  <a:solidFill>
                    <a:srgbClr val="FF0000"/>
                  </a:solidFill>
                </a:uFill>
                <a:latin typeface="Arial" charset="0"/>
                <a:ea typeface="Arial" charset="0"/>
                <a:cs typeface="Arial" charset="0"/>
                <a:sym typeface="ＭＳ Ｐゴシック" charset="0"/>
              </a:rPr>
              <a:t>Weeks after first infusion</a:t>
            </a:r>
            <a:endParaRPr kumimoji="0" lang="ja-JP" altLang="en-US" sz="1050" dirty="0">
              <a:uFill>
                <a:solidFill>
                  <a:srgbClr val="FF0000"/>
                </a:solidFill>
              </a:uFill>
              <a:latin typeface="Arial" charset="0"/>
              <a:ea typeface="Arial" charset="0"/>
              <a:cs typeface="Arial" charset="0"/>
              <a:sym typeface="ＭＳ Ｐゴシック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979971" y="3500027"/>
            <a:ext cx="4827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0w</a:t>
            </a:r>
            <a:endParaRPr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860792" y="3500027"/>
            <a:ext cx="4827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3w</a:t>
            </a:r>
            <a:endParaRPr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741613" y="3500027"/>
            <a:ext cx="4827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9w</a:t>
            </a:r>
            <a:endParaRPr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622433" y="3500027"/>
            <a:ext cx="4827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12w</a:t>
            </a:r>
            <a:endParaRPr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 bwMode="auto">
          <a:xfrm rot="16200000">
            <a:off x="492920" y="2496074"/>
            <a:ext cx="2295255" cy="253916"/>
          </a:xfrm>
          <a:prstGeom prst="rect">
            <a:avLst/>
          </a:prstGeom>
          <a:noFill/>
          <a:ln w="28575" cmpd="sng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0" lang="en-US" altLang="ja-JP" sz="1050" dirty="0">
                <a:uFill>
                  <a:solidFill>
                    <a:srgbClr val="FF0000"/>
                  </a:solidFill>
                </a:uFill>
                <a:latin typeface="Arial" charset="0"/>
                <a:ea typeface="Arial" charset="0"/>
                <a:cs typeface="Arial" charset="0"/>
                <a:sym typeface="ＭＳ Ｐゴシック" charset="0"/>
              </a:rPr>
              <a:t>Drug persistence rate</a:t>
            </a:r>
            <a:endParaRPr kumimoji="0" lang="ja-JP" altLang="en-US" sz="1050" dirty="0">
              <a:uFill>
                <a:solidFill>
                  <a:srgbClr val="FF0000"/>
                </a:solidFill>
              </a:uFill>
              <a:latin typeface="Arial" charset="0"/>
              <a:ea typeface="Arial" charset="0"/>
              <a:cs typeface="Arial" charset="0"/>
              <a:sym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9782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344E8BE-4DD6-4D44-953C-0A3EB816526B}"/>
              </a:ext>
            </a:extLst>
          </p:cNvPr>
          <p:cNvSpPr/>
          <p:nvPr/>
        </p:nvSpPr>
        <p:spPr>
          <a:xfrm>
            <a:off x="339111" y="689173"/>
            <a:ext cx="2108919" cy="52141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sessed for eligibility</a:t>
            </a:r>
          </a:p>
          <a:p>
            <a:pPr algn="ctr"/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7)</a:t>
            </a:r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D9ACE69-C91C-BA43-A3F0-1AD0CD14AD34}"/>
              </a:ext>
            </a:extLst>
          </p:cNvPr>
          <p:cNvSpPr/>
          <p:nvPr/>
        </p:nvSpPr>
        <p:spPr>
          <a:xfrm>
            <a:off x="277423" y="2458914"/>
            <a:ext cx="2232294" cy="39656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 analysis population (n=100)</a:t>
            </a:r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40F40C9-B955-CB4A-8528-64DC63269ECE}"/>
              </a:ext>
            </a:extLst>
          </p:cNvPr>
          <p:cNvSpPr/>
          <p:nvPr/>
        </p:nvSpPr>
        <p:spPr>
          <a:xfrm>
            <a:off x="2855120" y="1369199"/>
            <a:ext cx="2697724" cy="7543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(n=7)</a:t>
            </a:r>
            <a:endParaRPr lang="en-US" altLang="ja-JP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ja-JP" alt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meeting inclusion criteria (n=7)</a:t>
            </a:r>
            <a:endParaRPr kumimoji="1"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050ABE73-FD88-BE49-84F5-8BF83C5AFFD8}"/>
              </a:ext>
            </a:extLst>
          </p:cNvPr>
          <p:cNvSpPr/>
          <p:nvPr/>
        </p:nvSpPr>
        <p:spPr>
          <a:xfrm>
            <a:off x="518310" y="3825883"/>
            <a:ext cx="1771164" cy="55584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leted treatment (n=92)</a:t>
            </a: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46E1804D-5AAB-E84F-B81F-A3343E90BF88}"/>
              </a:ext>
            </a:extLst>
          </p:cNvPr>
          <p:cNvCxnSpPr>
            <a:cxnSpLocks/>
            <a:stCxn id="2" idx="2"/>
            <a:endCxn id="3" idx="0"/>
          </p:cNvCxnSpPr>
          <p:nvPr/>
        </p:nvCxnSpPr>
        <p:spPr>
          <a:xfrm flipH="1">
            <a:off x="1393570" y="1210586"/>
            <a:ext cx="1" cy="124832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142F88C9-1C96-A449-82E1-B8311FD08B01}"/>
              </a:ext>
            </a:extLst>
          </p:cNvPr>
          <p:cNvCxnSpPr>
            <a:cxnSpLocks/>
            <a:stCxn id="3" idx="2"/>
            <a:endCxn id="5" idx="0"/>
          </p:cNvCxnSpPr>
          <p:nvPr/>
        </p:nvCxnSpPr>
        <p:spPr>
          <a:xfrm>
            <a:off x="1393570" y="2855478"/>
            <a:ext cx="10322" cy="97040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05DCBF98-3654-FF45-90D0-BD0C6C5267A0}"/>
              </a:ext>
            </a:extLst>
          </p:cNvPr>
          <p:cNvCxnSpPr>
            <a:cxnSpLocks/>
          </p:cNvCxnSpPr>
          <p:nvPr/>
        </p:nvCxnSpPr>
        <p:spPr>
          <a:xfrm>
            <a:off x="1393570" y="1746359"/>
            <a:ext cx="144090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CC58843-F8FD-914A-82B6-9A660269BBF6}"/>
              </a:ext>
            </a:extLst>
          </p:cNvPr>
          <p:cNvSpPr/>
          <p:nvPr/>
        </p:nvSpPr>
        <p:spPr>
          <a:xfrm>
            <a:off x="2878992" y="2963519"/>
            <a:ext cx="2247779" cy="75432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ontinued treatment (n=8)</a:t>
            </a:r>
          </a:p>
          <a:p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ja-JP" alt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adequate effect</a:t>
            </a:r>
            <a:r>
              <a:rPr lang="ja-JP" altLang="ja-JP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6)</a:t>
            </a:r>
          </a:p>
          <a:p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ja-JP" alt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lang="en-US" altLang="ja-JP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verse event (n=2)</a:t>
            </a:r>
            <a:endParaRPr lang="ja-JP" altLang="en-US" sz="12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5A6EF173-9694-0A4C-B1A7-523B7BB632F5}"/>
              </a:ext>
            </a:extLst>
          </p:cNvPr>
          <p:cNvCxnSpPr>
            <a:cxnSpLocks/>
          </p:cNvCxnSpPr>
          <p:nvPr/>
        </p:nvCxnSpPr>
        <p:spPr>
          <a:xfrm>
            <a:off x="1414212" y="3340680"/>
            <a:ext cx="144090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9AFC197-C8E5-7E43-8ECF-E895D7193BE7}"/>
              </a:ext>
            </a:extLst>
          </p:cNvPr>
          <p:cNvSpPr/>
          <p:nvPr/>
        </p:nvSpPr>
        <p:spPr>
          <a:xfrm>
            <a:off x="100365" y="60216"/>
            <a:ext cx="177116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kern="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upplementary figure S2. </a:t>
            </a:r>
            <a:endParaRPr lang="ja-JP" altLang="ja-JP" sz="1000" kern="1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9954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48</TotalTime>
  <Words>83</Words>
  <Application>Microsoft Macintosh PowerPoint</Application>
  <PresentationFormat>A4 210 x 297 mm</PresentationFormat>
  <Paragraphs>1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Yu Gothic</vt:lpstr>
      <vt:lpstr>Arial</vt:lpstr>
      <vt:lpstr>Calibri</vt:lpstr>
      <vt:lpstr>Office 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beckham</dc:creator>
  <cp:lastModifiedBy>宮崎 佑介</cp:lastModifiedBy>
  <cp:revision>1220</cp:revision>
  <cp:lastPrinted>2018-05-23T02:40:26Z</cp:lastPrinted>
  <dcterms:created xsi:type="dcterms:W3CDTF">2012-04-06T00:31:26Z</dcterms:created>
  <dcterms:modified xsi:type="dcterms:W3CDTF">2021-04-29T03:11:05Z</dcterms:modified>
</cp:coreProperties>
</file>